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8000663" cy="180006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70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9" d="100"/>
          <a:sy n="59" d="100"/>
        </p:scale>
        <p:origin x="2388" y="116"/>
      </p:cViewPr>
      <p:guideLst>
        <p:guide orient="horz" pos="5670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1865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98507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310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9395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596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1034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6493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4029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95167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97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573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  <a:t>2026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3988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D7EE7CB4-95BF-4EFD-BE8A-EBAF3DB7FBD6}"/>
              </a:ext>
            </a:extLst>
          </p:cNvPr>
          <p:cNvSpPr txBox="1"/>
          <p:nvPr/>
        </p:nvSpPr>
        <p:spPr>
          <a:xfrm>
            <a:off x="2006110" y="15112837"/>
            <a:ext cx="1438662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5—figure supplement 2—source data 3. PowerPoint file containing original western blots for Figure 4—figure supplement 7d, indicating the relevant bands and treatments.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FBAA76FF-D5D5-4B48-A47F-B0A10A8CF3D3}"/>
              </a:ext>
            </a:extLst>
          </p:cNvPr>
          <p:cNvSpPr txBox="1"/>
          <p:nvPr/>
        </p:nvSpPr>
        <p:spPr>
          <a:xfrm>
            <a:off x="11840534" y="7596887"/>
            <a:ext cx="305663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Fig.S25d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组合 3">
            <a:extLst>
              <a:ext uri="{FF2B5EF4-FFF2-40B4-BE49-F238E27FC236}">
                <a16:creationId xmlns:a16="http://schemas.microsoft.com/office/drawing/2014/main" id="{2EE141C5-92F5-408C-A0B8-A199F2CAFEB2}"/>
              </a:ext>
            </a:extLst>
          </p:cNvPr>
          <p:cNvGrpSpPr/>
          <p:nvPr/>
        </p:nvGrpSpPr>
        <p:grpSpPr>
          <a:xfrm>
            <a:off x="2006110" y="2626216"/>
            <a:ext cx="5658243" cy="4058208"/>
            <a:chOff x="2117350" y="11820251"/>
            <a:chExt cx="11674851" cy="6122194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BEB3496F-279B-4FDB-B976-FA3C7D34B24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61469" y="11820251"/>
              <a:ext cx="10930732" cy="6122194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4AE2ABE7-7BAD-46D3-9789-97F7CFD4049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17350" y="11820251"/>
              <a:ext cx="744119" cy="5934349"/>
            </a:xfrm>
            <a:prstGeom prst="rect">
              <a:avLst/>
            </a:prstGeom>
          </p:spPr>
        </p:pic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1D0CAC35-6D47-48EC-AC4F-4D1E252B7830}"/>
                </a:ext>
              </a:extLst>
            </p:cNvPr>
            <p:cNvSpPr/>
            <p:nvPr/>
          </p:nvSpPr>
          <p:spPr>
            <a:xfrm>
              <a:off x="2957216" y="14097000"/>
              <a:ext cx="10834985" cy="2001794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/>
            </a:p>
          </p:txBody>
        </p:sp>
      </p:grpSp>
      <p:grpSp>
        <p:nvGrpSpPr>
          <p:cNvPr id="8" name="组合 7">
            <a:extLst>
              <a:ext uri="{FF2B5EF4-FFF2-40B4-BE49-F238E27FC236}">
                <a16:creationId xmlns:a16="http://schemas.microsoft.com/office/drawing/2014/main" id="{A84CE30A-1A65-4F45-B638-03931994E9BB}"/>
              </a:ext>
            </a:extLst>
          </p:cNvPr>
          <p:cNvGrpSpPr/>
          <p:nvPr/>
        </p:nvGrpSpPr>
        <p:grpSpPr>
          <a:xfrm>
            <a:off x="10106734" y="2722404"/>
            <a:ext cx="5860476" cy="4152919"/>
            <a:chOff x="13239412" y="11956647"/>
            <a:chExt cx="11373188" cy="5849402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7D83AC10-40B0-45C9-9312-304D5F1D2C0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4346238" y="11956647"/>
              <a:ext cx="10266362" cy="5849402"/>
            </a:xfrm>
            <a:prstGeom prst="rect">
              <a:avLst/>
            </a:prstGeom>
          </p:spPr>
        </p:pic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F490AD87-5649-4A10-9691-2CC98B3C520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3239412" y="12446194"/>
              <a:ext cx="1289844" cy="5308406"/>
            </a:xfrm>
            <a:prstGeom prst="rect">
              <a:avLst/>
            </a:prstGeom>
          </p:spPr>
        </p:pic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C074165B-C44D-4C49-8CB9-B78BED89B8DF}"/>
                </a:ext>
              </a:extLst>
            </p:cNvPr>
            <p:cNvSpPr/>
            <p:nvPr/>
          </p:nvSpPr>
          <p:spPr>
            <a:xfrm>
              <a:off x="14473238" y="12879554"/>
              <a:ext cx="9936162" cy="2001794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600"/>
            </a:p>
          </p:txBody>
        </p:sp>
      </p:grpSp>
      <p:pic>
        <p:nvPicPr>
          <p:cNvPr id="12" name="图片 11">
            <a:extLst>
              <a:ext uri="{FF2B5EF4-FFF2-40B4-BE49-F238E27FC236}">
                <a16:creationId xmlns:a16="http://schemas.microsoft.com/office/drawing/2014/main" id="{0DCB7711-2767-409E-8A8C-7C8BA830DF4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23034" y="10479241"/>
            <a:ext cx="5712070" cy="3435318"/>
          </a:xfrm>
          <a:prstGeom prst="rect">
            <a:avLst/>
          </a:prstGeom>
        </p:spPr>
      </p:pic>
      <p:grpSp>
        <p:nvGrpSpPr>
          <p:cNvPr id="13" name="组合 12">
            <a:extLst>
              <a:ext uri="{FF2B5EF4-FFF2-40B4-BE49-F238E27FC236}">
                <a16:creationId xmlns:a16="http://schemas.microsoft.com/office/drawing/2014/main" id="{9E54221B-2EBA-4FB4-A5B1-D1C18A52C39E}"/>
              </a:ext>
            </a:extLst>
          </p:cNvPr>
          <p:cNvGrpSpPr/>
          <p:nvPr/>
        </p:nvGrpSpPr>
        <p:grpSpPr>
          <a:xfrm>
            <a:off x="548353" y="372983"/>
            <a:ext cx="15145541" cy="2102513"/>
            <a:chOff x="3894933" y="34732441"/>
            <a:chExt cx="14008342" cy="1563624"/>
          </a:xfrm>
        </p:grpSpPr>
        <p:pic>
          <p:nvPicPr>
            <p:cNvPr id="14" name="图片 13">
              <a:extLst>
                <a:ext uri="{FF2B5EF4-FFF2-40B4-BE49-F238E27FC236}">
                  <a16:creationId xmlns:a16="http://schemas.microsoft.com/office/drawing/2014/main" id="{BBE082B6-EC13-47A4-9CC9-CCA90AC6509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894933" y="34732441"/>
              <a:ext cx="6410325" cy="1495425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D34438A5-8FE3-412F-8283-891B69CE710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1492950" y="34800640"/>
              <a:ext cx="6410325" cy="1495425"/>
            </a:xfrm>
            <a:prstGeom prst="rect">
              <a:avLst/>
            </a:prstGeom>
          </p:spPr>
        </p:pic>
      </p:grpSp>
      <p:sp>
        <p:nvSpPr>
          <p:cNvPr id="18" name="文本框 17">
            <a:extLst>
              <a:ext uri="{FF2B5EF4-FFF2-40B4-BE49-F238E27FC236}">
                <a16:creationId xmlns:a16="http://schemas.microsoft.com/office/drawing/2014/main" id="{D1E4E2DF-81B7-4237-8B9E-C891EA278D64}"/>
              </a:ext>
            </a:extLst>
          </p:cNvPr>
          <p:cNvSpPr txBox="1"/>
          <p:nvPr/>
        </p:nvSpPr>
        <p:spPr>
          <a:xfrm>
            <a:off x="4337838" y="6838795"/>
            <a:ext cx="20430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flag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FAF31731-423D-4BC6-9E9F-B280C5ABCAE7}"/>
              </a:ext>
            </a:extLst>
          </p:cNvPr>
          <p:cNvSpPr txBox="1"/>
          <p:nvPr/>
        </p:nvSpPr>
        <p:spPr>
          <a:xfrm>
            <a:off x="11840534" y="6875956"/>
            <a:ext cx="20430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3B55FFB9-78D2-4F52-8EE0-D2262F452DC2}"/>
              </a:ext>
            </a:extLst>
          </p:cNvPr>
          <p:cNvSpPr txBox="1"/>
          <p:nvPr/>
        </p:nvSpPr>
        <p:spPr>
          <a:xfrm>
            <a:off x="6925226" y="13914558"/>
            <a:ext cx="20430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000" dirty="0">
                <a:latin typeface="Arial" panose="020B0604020202020204" pitchFamily="34" charset="0"/>
                <a:cs typeface="Arial" panose="020B0604020202020204" pitchFamily="34" charset="0"/>
              </a:rPr>
              <a:t>RbcL</a:t>
            </a:r>
            <a:endParaRPr lang="zh-CN" alt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1FC2FA1E-9292-4859-A03D-1C53F8308B1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275132" y="8856313"/>
            <a:ext cx="6114286" cy="17142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5497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40</Words>
  <Application>Microsoft Office PowerPoint</Application>
  <PresentationFormat>自定义</PresentationFormat>
  <Paragraphs>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HJHuang</cp:lastModifiedBy>
  <cp:revision>4</cp:revision>
  <dcterms:created xsi:type="dcterms:W3CDTF">2026-03-26T06:05:32Z</dcterms:created>
  <dcterms:modified xsi:type="dcterms:W3CDTF">2026-03-26T07:36:45Z</dcterms:modified>
</cp:coreProperties>
</file>